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6.png" ContentType="image/png"/>
  <Override PartName="/ppt/media/image7.png" ContentType="image/png"/>
  <Override PartName="/ppt/media/image11.wmf" ContentType="image/x-wmf"/>
  <Override PartName="/ppt/media/image8.png" ContentType="image/png"/>
  <Override PartName="/ppt/media/image12.wmf" ContentType="image/x-wmf"/>
  <Override PartName="/ppt/media/image9.png" ContentType="image/png"/>
  <Override PartName="/ppt/media/image10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1028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8000" cy="51264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8960" bIns="48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2280" y="0"/>
            <a:ext cx="3078360" cy="51264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8960" bIns="48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2480" y="766440"/>
            <a:ext cx="2878200" cy="3838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8280" rIns="9828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200" y="4862160"/>
            <a:ext cx="5683320" cy="460548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8960" bIns="489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0360"/>
            <a:ext cx="3078000" cy="51264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8960" bIns="489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2280" y="9720360"/>
            <a:ext cx="3078360" cy="512640"/>
          </a:xfrm>
          <a:prstGeom prst="rect">
            <a:avLst/>
          </a:prstGeom>
          <a:noFill/>
          <a:ln w="0">
            <a:noFill/>
          </a:ln>
        </p:spPr>
        <p:txBody>
          <a:bodyPr lIns="98280" rIns="98280" tIns="48960" bIns="4896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6FA886-5AF0-4690-9DBD-48A0E4B1A001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7"/>
          <p:cNvSpPr/>
          <p:nvPr/>
        </p:nvSpPr>
        <p:spPr>
          <a:xfrm>
            <a:off x="4022640" y="9720360"/>
            <a:ext cx="3078360" cy="51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93B0FA-552D-4908-9A2B-0A00623CC353}" type="slidenum">
              <a:rPr b="0" lang="es-E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2112840" y="766800"/>
            <a:ext cx="2878200" cy="383868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709200" y="4862160"/>
            <a:ext cx="5683320" cy="4605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4 Marcador de encabezado"/>
          <p:cNvSpPr/>
          <p:nvPr/>
        </p:nvSpPr>
        <p:spPr>
          <a:xfrm>
            <a:off x="0" y="0"/>
            <a:ext cx="3078000" cy="51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8280" rIns="98280" tIns="48960" bIns="48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211EE-434B-407F-836F-EFA808B810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163C3-391F-4CEE-91A2-06845D4D31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11447-1067-4460-8971-A980306F2F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4E92A-1849-4578-A87E-EC8D9D5B7A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D3B57-F2AC-4F2D-AFF7-EE11C4A43B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DA6AA3-E394-4FEC-8D5A-D2708E179E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3980E-FD35-4677-96DB-0F8FF5677B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C8FC3-B6DC-44EC-9854-68AA0ABF0D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5F6BE-C691-41FB-B274-E55AFB2087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13BEA-B5A6-4C20-A84D-5FFDB659F1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72204-AFAC-43DA-AE09-4A8482FCCA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7AF1A-8BA4-4EA8-8C7C-40758B10B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lorens et a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80C486-6019-4A39-BF7D-A7A8B07AD5C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0" descr=""/>
          <p:cNvPicPr/>
          <p:nvPr/>
        </p:nvPicPr>
        <p:blipFill>
          <a:blip r:embed="rId1"/>
          <a:stretch/>
        </p:blipFill>
        <p:spPr>
          <a:xfrm>
            <a:off x="3726000" y="1096920"/>
            <a:ext cx="3132000" cy="1789200"/>
          </a:xfrm>
          <a:prstGeom prst="rect">
            <a:avLst/>
          </a:prstGeom>
          <a:ln w="0">
            <a:noFill/>
          </a:ln>
        </p:spPr>
      </p:pic>
      <p:sp>
        <p:nvSpPr>
          <p:cNvPr id="49" name="Text Box 6"/>
          <p:cNvSpPr/>
          <p:nvPr/>
        </p:nvSpPr>
        <p:spPr>
          <a:xfrm>
            <a:off x="5541480" y="2679840"/>
            <a:ext cx="57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ime (h)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623160" y="5008680"/>
            <a:ext cx="166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     5’    6h   24h    5’    6h   24h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2178360" y="4149720"/>
            <a:ext cx="54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-Cyclin E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6"/>
          <p:cNvSpPr/>
          <p:nvPr/>
        </p:nvSpPr>
        <p:spPr>
          <a:xfrm>
            <a:off x="2184480" y="4371840"/>
            <a:ext cx="48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-p27 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 Narrow"/>
              </a:rPr>
              <a:t>Kip1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7"/>
          <p:cNvSpPr/>
          <p:nvPr/>
        </p:nvSpPr>
        <p:spPr>
          <a:xfrm>
            <a:off x="907920" y="3537000"/>
            <a:ext cx="638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8"/>
          <p:cNvSpPr/>
          <p:nvPr/>
        </p:nvSpPr>
        <p:spPr>
          <a:xfrm>
            <a:off x="1039680" y="3357720"/>
            <a:ext cx="39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GF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2176560" y="3865680"/>
            <a:ext cx="59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-Cyclin D1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20" descr=""/>
          <p:cNvPicPr/>
          <p:nvPr/>
        </p:nvPicPr>
        <p:blipFill>
          <a:blip r:embed="rId2"/>
          <a:srcRect l="16191" t="0" r="11813" b="10996"/>
          <a:stretch/>
        </p:blipFill>
        <p:spPr>
          <a:xfrm>
            <a:off x="585000" y="4120560"/>
            <a:ext cx="1668600" cy="2458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1" descr=""/>
          <p:cNvPicPr/>
          <p:nvPr/>
        </p:nvPicPr>
        <p:blipFill>
          <a:blip r:embed="rId3"/>
          <a:srcRect l="0" t="27007" r="3010" b="21234"/>
          <a:stretch/>
        </p:blipFill>
        <p:spPr>
          <a:xfrm>
            <a:off x="585000" y="3834720"/>
            <a:ext cx="1668600" cy="250920"/>
          </a:xfrm>
          <a:prstGeom prst="rect">
            <a:avLst/>
          </a:prstGeom>
          <a:ln w="0">
            <a:noFill/>
          </a:ln>
        </p:spPr>
      </p:pic>
      <p:sp>
        <p:nvSpPr>
          <p:cNvPr id="58" name="Line 22"/>
          <p:cNvSpPr/>
          <p:nvPr/>
        </p:nvSpPr>
        <p:spPr>
          <a:xfrm>
            <a:off x="1619280" y="3540240"/>
            <a:ext cx="66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3"/>
          <p:cNvSpPr/>
          <p:nvPr/>
        </p:nvSpPr>
        <p:spPr>
          <a:xfrm>
            <a:off x="1585080" y="335916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GF+U0126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2176560" y="4678200"/>
            <a:ext cx="51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-Tubulin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25" descr=""/>
          <p:cNvPicPr/>
          <p:nvPr/>
        </p:nvPicPr>
        <p:blipFill>
          <a:blip r:embed="rId4">
            <a:lum bright="-12000"/>
          </a:blip>
          <a:srcRect l="5854" t="9386" r="9121" b="0"/>
          <a:stretch/>
        </p:blipFill>
        <p:spPr>
          <a:xfrm>
            <a:off x="585720" y="4683240"/>
            <a:ext cx="1668600" cy="2696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6" descr=""/>
          <p:cNvPicPr/>
          <p:nvPr/>
        </p:nvPicPr>
        <p:blipFill>
          <a:blip r:embed="rId5">
            <a:lum bright="-12000"/>
          </a:blip>
          <a:srcRect l="8022" t="32061" r="9570" b="28268"/>
          <a:stretch/>
        </p:blipFill>
        <p:spPr>
          <a:xfrm>
            <a:off x="585720" y="4390920"/>
            <a:ext cx="1668600" cy="26352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7" descr=""/>
          <p:cNvPicPr/>
          <p:nvPr/>
        </p:nvPicPr>
        <p:blipFill>
          <a:blip r:embed="rId6">
            <a:lum bright="-12000"/>
          </a:blip>
          <a:srcRect l="8834" t="17788" r="1959" b="19171"/>
          <a:stretch/>
        </p:blipFill>
        <p:spPr>
          <a:xfrm>
            <a:off x="581040" y="3567240"/>
            <a:ext cx="1671480" cy="245880"/>
          </a:xfrm>
          <a:prstGeom prst="rect">
            <a:avLst/>
          </a:prstGeom>
          <a:ln w="0">
            <a:noFill/>
          </a:ln>
        </p:spPr>
      </p:pic>
      <p:sp>
        <p:nvSpPr>
          <p:cNvPr id="64" name="Text Box 28"/>
          <p:cNvSpPr/>
          <p:nvPr/>
        </p:nvSpPr>
        <p:spPr>
          <a:xfrm>
            <a:off x="2181960" y="3586320"/>
            <a:ext cx="58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 Narrow"/>
              </a:rPr>
              <a:t>-P-ERK1/2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"/>
          <p:cNvSpPr/>
          <p:nvPr/>
        </p:nvSpPr>
        <p:spPr>
          <a:xfrm>
            <a:off x="53640" y="114156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0"/>
          <p:cNvSpPr/>
          <p:nvPr/>
        </p:nvSpPr>
        <p:spPr>
          <a:xfrm>
            <a:off x="3177720" y="114156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1"/>
          <p:cNvSpPr/>
          <p:nvPr/>
        </p:nvSpPr>
        <p:spPr>
          <a:xfrm>
            <a:off x="69480" y="347652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Group 32"/>
          <p:cNvGrpSpPr/>
          <p:nvPr/>
        </p:nvGrpSpPr>
        <p:grpSpPr>
          <a:xfrm>
            <a:off x="415800" y="1155600"/>
            <a:ext cx="2707200" cy="1493280"/>
            <a:chOff x="415800" y="1155600"/>
            <a:chExt cx="2707200" cy="1493280"/>
          </a:xfrm>
        </p:grpSpPr>
        <p:pic>
          <p:nvPicPr>
            <p:cNvPr id="69" name="Picture 33" descr=""/>
            <p:cNvPicPr/>
            <p:nvPr/>
          </p:nvPicPr>
          <p:blipFill>
            <a:blip r:embed="rId7"/>
            <a:srcRect l="19851" t="41800" r="11883" b="8410"/>
            <a:stretch/>
          </p:blipFill>
          <p:spPr>
            <a:xfrm>
              <a:off x="555480" y="1977840"/>
              <a:ext cx="1419480" cy="213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4" descr=""/>
            <p:cNvPicPr/>
            <p:nvPr/>
          </p:nvPicPr>
          <p:blipFill>
            <a:blip r:embed="rId8"/>
            <a:srcRect l="10596" t="-2322" r="13244" b="10526"/>
            <a:stretch/>
          </p:blipFill>
          <p:spPr>
            <a:xfrm>
              <a:off x="555480" y="2199960"/>
              <a:ext cx="141948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35" descr=""/>
            <p:cNvPicPr/>
            <p:nvPr/>
          </p:nvPicPr>
          <p:blipFill>
            <a:blip r:embed="rId9"/>
            <a:srcRect l="4849" t="14634" r="8199" b="0"/>
            <a:stretch/>
          </p:blipFill>
          <p:spPr>
            <a:xfrm>
              <a:off x="555480" y="1738080"/>
              <a:ext cx="1419480" cy="226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Rectangle 36"/>
            <p:cNvSpPr/>
            <p:nvPr/>
          </p:nvSpPr>
          <p:spPr>
            <a:xfrm>
              <a:off x="1882800" y="1964880"/>
              <a:ext cx="669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-P-CREB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7"/>
            <p:cNvSpPr/>
            <p:nvPr/>
          </p:nvSpPr>
          <p:spPr>
            <a:xfrm>
              <a:off x="1881000" y="2185560"/>
              <a:ext cx="871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-Tubulin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8"/>
            <p:cNvSpPr/>
            <p:nvPr/>
          </p:nvSpPr>
          <p:spPr>
            <a:xfrm>
              <a:off x="577080" y="2433240"/>
              <a:ext cx="254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      5     10    15   30    60       EGF (100ng/ml) min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9"/>
            <p:cNvSpPr/>
            <p:nvPr/>
          </p:nvSpPr>
          <p:spPr>
            <a:xfrm>
              <a:off x="1882800" y="1471320"/>
              <a:ext cx="617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-P-ERK1/2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0"/>
            <p:cNvSpPr/>
            <p:nvPr/>
          </p:nvSpPr>
          <p:spPr>
            <a:xfrm>
              <a:off x="1884240" y="1712520"/>
              <a:ext cx="973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-P-p90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 Narrow"/>
                </a:rPr>
                <a:t>rsk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Picture 41" descr=""/>
            <p:cNvPicPr/>
            <p:nvPr/>
          </p:nvPicPr>
          <p:blipFill>
            <a:blip r:embed="rId10"/>
            <a:srcRect l="15133" t="34379" r="8564" b="19100"/>
            <a:stretch/>
          </p:blipFill>
          <p:spPr>
            <a:xfrm>
              <a:off x="557280" y="1223640"/>
              <a:ext cx="1417680" cy="245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Rectangle 42"/>
            <p:cNvSpPr/>
            <p:nvPr/>
          </p:nvSpPr>
          <p:spPr>
            <a:xfrm>
              <a:off x="1879560" y="1218960"/>
              <a:ext cx="574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Narrow"/>
                </a:rPr>
                <a:t>-P-EGFR</a:t>
              </a: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Picture 43" descr=""/>
            <p:cNvPicPr/>
            <p:nvPr/>
          </p:nvPicPr>
          <p:blipFill>
            <a:blip r:embed="rId11"/>
            <a:srcRect l="10358" t="36492" r="6469" b="26250"/>
            <a:stretch/>
          </p:blipFill>
          <p:spPr>
            <a:xfrm>
              <a:off x="554040" y="1480680"/>
              <a:ext cx="1420920" cy="237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Rectangle 44"/>
            <p:cNvSpPr/>
            <p:nvPr/>
          </p:nvSpPr>
          <p:spPr>
            <a:xfrm>
              <a:off x="415800" y="1155600"/>
              <a:ext cx="146160" cy="1295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Text Box 45"/>
          <p:cNvSpPr/>
          <p:nvPr/>
        </p:nvSpPr>
        <p:spPr>
          <a:xfrm>
            <a:off x="3165120" y="347652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5"/>
          <p:cNvSpPr/>
          <p:nvPr/>
        </p:nvSpPr>
        <p:spPr>
          <a:xfrm>
            <a:off x="3820680" y="2471760"/>
            <a:ext cx="231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          1          2          3          4          5          6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7"/>
          <p:cNvSpPr/>
          <p:nvPr/>
        </p:nvSpPr>
        <p:spPr>
          <a:xfrm>
            <a:off x="3680640" y="1301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8"/>
          <p:cNvSpPr/>
          <p:nvPr/>
        </p:nvSpPr>
        <p:spPr>
          <a:xfrm>
            <a:off x="3680640" y="1573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"/>
          <p:cNvSpPr/>
          <p:nvPr/>
        </p:nvSpPr>
        <p:spPr>
          <a:xfrm>
            <a:off x="3680640" y="1843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0"/>
          <p:cNvSpPr/>
          <p:nvPr/>
        </p:nvSpPr>
        <p:spPr>
          <a:xfrm>
            <a:off x="3737160" y="2112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1"/>
          <p:cNvSpPr/>
          <p:nvPr/>
        </p:nvSpPr>
        <p:spPr>
          <a:xfrm>
            <a:off x="3737160" y="238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2"/>
          <p:cNvSpPr/>
          <p:nvPr/>
        </p:nvSpPr>
        <p:spPr>
          <a:xfrm>
            <a:off x="3703680" y="2655720"/>
            <a:ext cx="27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3"/>
          <p:cNvSpPr/>
          <p:nvPr/>
        </p:nvSpPr>
        <p:spPr>
          <a:xfrm rot="16200000">
            <a:off x="2833560" y="1814040"/>
            <a:ext cx="1613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old Induction  (EGF/Control)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48"/>
          <p:cNvSpPr/>
          <p:nvPr/>
        </p:nvSpPr>
        <p:spPr>
          <a:xfrm>
            <a:off x="3680640" y="10303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20" descr=""/>
          <p:cNvPicPr/>
          <p:nvPr/>
        </p:nvPicPr>
        <p:blipFill>
          <a:blip r:embed="rId12"/>
          <a:stretch/>
        </p:blipFill>
        <p:spPr>
          <a:xfrm>
            <a:off x="3745080" y="3591000"/>
            <a:ext cx="3009600" cy="1393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3T09:20:05Z</dcterms:created>
  <dc:creator>fllorens</dc:creator>
  <dc:description/>
  <dc:language>en-US</dc:language>
  <cp:lastModifiedBy>lsumoy</cp:lastModifiedBy>
  <dcterms:modified xsi:type="dcterms:W3CDTF">2011-06-22T19:44:03Z</dcterms:modified>
  <cp:revision>833</cp:revision>
  <dc:subject/>
  <dc:title>Diapositiva 1</dc:title>
</cp:coreProperties>
</file>